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0" d="100"/>
          <a:sy n="70" d="100"/>
        </p:scale>
        <p:origin x="73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9D5151-BD16-4916-BF66-3FC15286188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4914751-AB0F-402F-A1D6-376C1DA1D05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EC6ABC-87C7-49D9-8C42-AE971B2094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660B9-B507-4EBE-AE8E-DA703E7CFB0F}" type="datetimeFigureOut">
              <a:rPr lang="en-US" smtClean="0"/>
              <a:t>12/8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7B52E7-2468-4E05-97DD-F359E445EE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7BB342-C67B-4AB3-9263-78B5A95853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B7F31-DF4F-45BB-BDBD-AC43372227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37343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E10A18-E1A5-46BE-818E-7B05A4CD34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5C1591E-43EE-4EF5-88DB-62F643BB0AA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9E904C-0C9C-4465-8CFC-968D3A285C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660B9-B507-4EBE-AE8E-DA703E7CFB0F}" type="datetimeFigureOut">
              <a:rPr lang="en-US" smtClean="0"/>
              <a:t>12/8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8737D1-40BE-4867-9080-788AC87CAE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C44400-BF5D-4E3C-AFBD-7BB0B65C16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B7F31-DF4F-45BB-BDBD-AC43372227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59183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924F393-90E9-4DE9-AC94-035B4FE6E01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0B68903-EFC5-48D9-A2FA-735D7FCC52A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64584E-FDA0-406F-8A05-6FCA9E56E7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660B9-B507-4EBE-AE8E-DA703E7CFB0F}" type="datetimeFigureOut">
              <a:rPr lang="en-US" smtClean="0"/>
              <a:t>12/8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4F9B2B-69AB-4AD4-9A1C-DBA0F7242C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A2FDB1-2089-4E73-8AEA-D9A55D4BF4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B7F31-DF4F-45BB-BDBD-AC43372227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55654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D1D63D-1DF3-4A6B-B1E8-019F0147E6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CCB8CD-6B10-4CC9-8352-326545EFC5D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FFA4CC-CEC1-4237-AF08-F4F4343CD3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660B9-B507-4EBE-AE8E-DA703E7CFB0F}" type="datetimeFigureOut">
              <a:rPr lang="en-US" smtClean="0"/>
              <a:t>12/8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022A14-A8E6-4B06-8D64-54D3AE0F60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A4D8A6-4FEF-4A21-AEDE-255C2AF7FE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B7F31-DF4F-45BB-BDBD-AC43372227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17219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215273-A1F4-4E0C-B8A7-829F9D86A0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1616566-522F-4A85-A461-34241A3F37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1916F16-B1A9-46A6-A87F-439AEC33D5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660B9-B507-4EBE-AE8E-DA703E7CFB0F}" type="datetimeFigureOut">
              <a:rPr lang="en-US" smtClean="0"/>
              <a:t>12/8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50B15C-9CA1-4DF2-B709-BB0ACFC17A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600658-87C9-413B-A1EE-302DD40A61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B7F31-DF4F-45BB-BDBD-AC43372227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15418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762B3C-20AE-48E8-BE9B-2B1564D97E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800204D-6BE6-4A58-8C72-CC425A6D5E2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815EB4E-2F75-4EE1-8BCA-0F2854DC7B5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1275983-4552-4CD4-BA66-477718A12B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660B9-B507-4EBE-AE8E-DA703E7CFB0F}" type="datetimeFigureOut">
              <a:rPr lang="en-US" smtClean="0"/>
              <a:t>12/8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91B8A32-D360-4220-8A4C-51B3F93BA1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994952A-6E71-477F-9165-983B24AEDB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B7F31-DF4F-45BB-BDBD-AC43372227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8903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F20E6A-9B15-4E04-A71D-76BD9F6C55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C478A03-061E-4DFE-BC1F-379C8AC1A9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16A298B-1358-4CCC-9BD5-38C2C889728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1F40A75-9ACE-408E-BBF1-2049E5A6429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D888538-1EF4-4C19-8494-7FF5500600C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A612E1A-3B8F-414D-8B6E-64AA764AB5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660B9-B507-4EBE-AE8E-DA703E7CFB0F}" type="datetimeFigureOut">
              <a:rPr lang="en-US" smtClean="0"/>
              <a:t>12/8/20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2BCFB0F-A3A0-4A12-BF27-F3CCD197A6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B469DDF-B1D4-4F13-B3AE-036BBAEC25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B7F31-DF4F-45BB-BDBD-AC43372227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87409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033271-F4F5-414A-B332-C66EBD76F1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9751A02-DE0A-4F99-AAAF-EB8E616BBA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660B9-B507-4EBE-AE8E-DA703E7CFB0F}" type="datetimeFigureOut">
              <a:rPr lang="en-US" smtClean="0"/>
              <a:t>12/8/20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C57F454-50AC-4DA0-8611-72E7CFAE16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2A96552-CC12-41DE-876D-63BD45339F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B7F31-DF4F-45BB-BDBD-AC43372227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52878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D5FCD53-B4E7-43BF-AFA9-B992971E1D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660B9-B507-4EBE-AE8E-DA703E7CFB0F}" type="datetimeFigureOut">
              <a:rPr lang="en-US" smtClean="0"/>
              <a:t>12/8/20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2F05B42-39AA-4966-84BD-F307557ABA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4535DCB-F419-4748-9346-F0CA322159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B7F31-DF4F-45BB-BDBD-AC43372227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73253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408E6A-5F34-48EA-ABE5-86CB296B92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B148022-6BBA-41E3-B32E-CD5E399C487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4FFEE8F-AE23-4BAC-B696-FB1CDD6CD53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A6429FE-65A9-4671-A92D-7BD6FB153C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660B9-B507-4EBE-AE8E-DA703E7CFB0F}" type="datetimeFigureOut">
              <a:rPr lang="en-US" smtClean="0"/>
              <a:t>12/8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F8C5F85-0FC2-4C47-BF23-4E85F42EE0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0160F90-5A5C-4BD5-B5FF-4F2B5A5ADB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B7F31-DF4F-45BB-BDBD-AC43372227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12376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9635C7-464A-461F-81D5-A5224F8BDA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F880045-B7FF-4819-AE48-674B936FF12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E6C66C3-691B-4EA7-B915-73F5871DE3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683B808-26E4-43EB-A6C3-260E1F616C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660B9-B507-4EBE-AE8E-DA703E7CFB0F}" type="datetimeFigureOut">
              <a:rPr lang="en-US" smtClean="0"/>
              <a:t>12/8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BDE512E-FC9D-4BE6-9249-D8FABA6E82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7EA2D84-13A5-4B50-8416-1230809771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B7F31-DF4F-45BB-BDBD-AC43372227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9405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14A6DA9-65A5-4994-B945-DC1D2C667D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FA29253-2811-434F-89B4-22427F80745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673032-06F4-4716-896A-E5F94FF063B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D660B9-B507-4EBE-AE8E-DA703E7CFB0F}" type="datetimeFigureOut">
              <a:rPr lang="en-US" smtClean="0"/>
              <a:t>12/8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99F0769-54B8-40B6-9901-21A0D27062D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EE3218-8AC4-48F1-8018-67BDDB9DD7E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4B7F31-DF4F-45BB-BDBD-AC43372227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86451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697E73DD-C258-4BD6-A1CF-150E54B9730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54093212"/>
              </p:ext>
            </p:extLst>
          </p:nvPr>
        </p:nvGraphicFramePr>
        <p:xfrm>
          <a:off x="3853425" y="562442"/>
          <a:ext cx="4529061" cy="376913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Prism 8" r:id="rId3" imgW="3538694" imgH="2944259" progId="Prism8.Document">
                  <p:embed/>
                </p:oleObj>
              </mc:Choice>
              <mc:Fallback>
                <p:oleObj name="Prism 8" r:id="rId3" imgW="3538694" imgH="2944259" progId="Prism8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697E73DD-C258-4BD6-A1CF-150E54B9730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853425" y="562442"/>
                        <a:ext cx="4529061" cy="376913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文字方塊 3">
            <a:extLst>
              <a:ext uri="{FF2B5EF4-FFF2-40B4-BE49-F238E27FC236}">
                <a16:creationId xmlns:a16="http://schemas.microsoft.com/office/drawing/2014/main" id="{062E14F1-142F-424E-B289-194C76282F48}"/>
              </a:ext>
            </a:extLst>
          </p:cNvPr>
          <p:cNvSpPr txBox="1"/>
          <p:nvPr/>
        </p:nvSpPr>
        <p:spPr>
          <a:xfrm>
            <a:off x="143365" y="193110"/>
            <a:ext cx="2286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Supplemental Figure 1</a:t>
            </a:r>
            <a:endParaRPr lang="zh-TW" altLang="en-US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2189157-1A17-4971-8C08-B326FA0E322E}"/>
              </a:ext>
            </a:extLst>
          </p:cNvPr>
          <p:cNvSpPr txBox="1"/>
          <p:nvPr/>
        </p:nvSpPr>
        <p:spPr>
          <a:xfrm>
            <a:off x="880974" y="4331581"/>
            <a:ext cx="1091069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l Fig. 1. Testing the ability of CN1030 and CN3080 to enrich VEEV.</a:t>
            </a:r>
            <a:r>
              <a:rPr lang="en-US" dirty="0"/>
              <a:t> VEEV at 1x10</a:t>
            </a:r>
            <a:r>
              <a:rPr lang="en-US" baseline="30000" dirty="0"/>
              <a:t>6</a:t>
            </a:r>
            <a:r>
              <a:rPr lang="en-US" dirty="0"/>
              <a:t> PFU/mL was spiked into DMEM followed by incubation with CN1030 (non-magnetic) or CN3080 (magnetic) NT particles. Samples without NT particles were included as a control (-NT). The genomic copies of VEEV were determined by RT-qPCR after incubation for 30 min in presence of NT. Data were presented as mean ± SEM from three biological replicates. </a:t>
            </a:r>
          </a:p>
        </p:txBody>
      </p:sp>
    </p:spTree>
    <p:extLst>
      <p:ext uri="{BB962C8B-B14F-4D97-AF65-F5344CB8AC3E}">
        <p14:creationId xmlns:p14="http://schemas.microsoft.com/office/powerpoint/2010/main" val="1165137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88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新細明體</vt:lpstr>
      <vt:lpstr>Arial</vt:lpstr>
      <vt:lpstr>Calibri</vt:lpstr>
      <vt:lpstr>Calibri Light</vt:lpstr>
      <vt:lpstr>Office Theme</vt:lpstr>
      <vt:lpstr>Prism 8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ylene Kehn-Hall</dc:creator>
  <cp:lastModifiedBy>Kylene Kehn-Hall</cp:lastModifiedBy>
  <cp:revision>2</cp:revision>
  <dcterms:created xsi:type="dcterms:W3CDTF">2019-12-08T19:41:12Z</dcterms:created>
  <dcterms:modified xsi:type="dcterms:W3CDTF">2019-12-08T19:46:50Z</dcterms:modified>
</cp:coreProperties>
</file>